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41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14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157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567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027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90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877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782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264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712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706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811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193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5D405-45B5-4EF2-861C-ACE91250DA70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BBE1E-D202-43A3-B8CC-335CE52CE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282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microsoft.com/office/2007/relationships/hdphoto" Target="../media/hdphoto2.wdp"/><Relationship Id="rId4" Type="http://schemas.openxmlformats.org/officeDocument/2006/relationships/image" Target="../media/image6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724745" y="3757268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197870" y="1856932"/>
            <a:ext cx="9957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cramble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936838" y="2045470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139980" y="1860804"/>
            <a:ext cx="6960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617163" y="1860804"/>
            <a:ext cx="10871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-CD36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 OxLDL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888251" y="2567994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cxnSp>
        <p:nvCxnSpPr>
          <p:cNvPr id="38" name="Straight Connector 37"/>
          <p:cNvCxnSpPr/>
          <p:nvPr/>
        </p:nvCxnSpPr>
        <p:spPr>
          <a:xfrm>
            <a:off x="3368831" y="2284208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4173713" y="2284208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978595" y="2287426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5783477" y="2284208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5971" y="2393749"/>
            <a:ext cx="4523624" cy="99754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5971" y="3529977"/>
            <a:ext cx="4627855" cy="731583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19075" y="1487600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-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73997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84432" y="4495799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39643" y="286305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2669140" y="2041598"/>
            <a:ext cx="624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220409" y="2041598"/>
            <a:ext cx="860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423552" y="1856932"/>
            <a:ext cx="8689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021995" y="1856932"/>
            <a:ext cx="13571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-CD36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 OxLDL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2325255" y="2280336"/>
            <a:ext cx="6877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3293904" y="2280336"/>
            <a:ext cx="6877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4262167" y="2283554"/>
            <a:ext cx="6877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5219449" y="2280336"/>
            <a:ext cx="68777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5351" y="3892460"/>
            <a:ext cx="4938188" cy="123149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8797" y="2372744"/>
            <a:ext cx="4846740" cy="1481456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219075" y="1487600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-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6813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620103" y="2438506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7880" t="11534" r="22376" b="73015"/>
          <a:stretch/>
        </p:blipFill>
        <p:spPr>
          <a:xfrm>
            <a:off x="1359408" y="2349809"/>
            <a:ext cx="3310128" cy="429768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276073" y="1261486"/>
            <a:ext cx="9957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cramble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015041" y="1450024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218183" y="1265358"/>
            <a:ext cx="6960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695366" y="1265358"/>
            <a:ext cx="10871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-CD36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 OxLDL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83609" y="1866384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7701" t="46928" r="24593" b="44580"/>
          <a:stretch/>
        </p:blipFill>
        <p:spPr>
          <a:xfrm>
            <a:off x="1359408" y="1765283"/>
            <a:ext cx="3310128" cy="402336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620103" y="5572199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83609" y="488234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 contrast="20000"/>
                    </a14:imgEffect>
                  </a14:imgLayer>
                </a14:imgProps>
              </a:ext>
            </a:extLst>
          </a:blip>
          <a:srcRect l="2505" t="34661" r="24962" b="47585"/>
          <a:stretch/>
        </p:blipFill>
        <p:spPr>
          <a:xfrm>
            <a:off x="1359408" y="5457069"/>
            <a:ext cx="3310128" cy="49377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8"/>
          <a:srcRect l="5091" t="35176" r="27299" b="56933"/>
          <a:stretch/>
        </p:blipFill>
        <p:spPr>
          <a:xfrm>
            <a:off x="1359408" y="4788954"/>
            <a:ext cx="3310128" cy="463791"/>
          </a:xfrm>
          <a:prstGeom prst="rect">
            <a:avLst/>
          </a:prstGeom>
        </p:spPr>
      </p:pic>
      <p:cxnSp>
        <p:nvCxnSpPr>
          <p:cNvPr id="38" name="Straight Connector 37"/>
          <p:cNvCxnSpPr/>
          <p:nvPr/>
        </p:nvCxnSpPr>
        <p:spPr>
          <a:xfrm>
            <a:off x="1447034" y="1688762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2251916" y="1688762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056798" y="1691980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3861680" y="1688762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1538685" y="4511955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089955" y="4511955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293097" y="4327289"/>
            <a:ext cx="6960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-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770280" y="4327289"/>
            <a:ext cx="10871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NA-CD36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 OxLDL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1521948" y="4750693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2326830" y="4750693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3131712" y="4753911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3936594" y="4750693"/>
            <a:ext cx="55092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14784" y="1866384"/>
            <a:ext cx="3639627" cy="307265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0FEB928C-F288-4188-B672-440C7212669C}"/>
              </a:ext>
            </a:extLst>
          </p:cNvPr>
          <p:cNvSpPr txBox="1"/>
          <p:nvPr/>
        </p:nvSpPr>
        <p:spPr>
          <a:xfrm>
            <a:off x="8284556" y="253083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*</a:t>
            </a:r>
            <a:endParaRPr lang="en-US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0042391-1D56-4C5F-811D-FF87BE842686}"/>
              </a:ext>
            </a:extLst>
          </p:cNvPr>
          <p:cNvSpPr txBox="1"/>
          <p:nvPr/>
        </p:nvSpPr>
        <p:spPr>
          <a:xfrm>
            <a:off x="8859946" y="195871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**</a:t>
            </a:r>
            <a:endParaRPr lang="en-US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B90A7A9-1A31-4284-B24B-060F7CB7CE66}"/>
              </a:ext>
            </a:extLst>
          </p:cNvPr>
          <p:cNvSpPr txBox="1"/>
          <p:nvPr/>
        </p:nvSpPr>
        <p:spPr>
          <a:xfrm>
            <a:off x="9486715" y="238002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##</a:t>
            </a:r>
          </a:p>
        </p:txBody>
      </p:sp>
    </p:spTree>
    <p:extLst>
      <p:ext uri="{BB962C8B-B14F-4D97-AF65-F5344CB8AC3E}">
        <p14:creationId xmlns:p14="http://schemas.microsoft.com/office/powerpoint/2010/main" val="400271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</TotalTime>
  <Words>45</Words>
  <Application>Microsoft Office PowerPoint</Application>
  <PresentationFormat>Widescreen</PresentationFormat>
  <Paragraphs>3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, Rebecca</dc:creator>
  <cp:lastModifiedBy>Pillai, Sneha</cp:lastModifiedBy>
  <cp:revision>17</cp:revision>
  <dcterms:created xsi:type="dcterms:W3CDTF">2019-12-22T18:24:40Z</dcterms:created>
  <dcterms:modified xsi:type="dcterms:W3CDTF">2022-08-16T13:23:55Z</dcterms:modified>
</cp:coreProperties>
</file>